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4" r:id="rId2"/>
    <p:sldId id="263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7" d="100"/>
          <a:sy n="87" d="100"/>
        </p:scale>
        <p:origin x="222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___1.xlsx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lineChart>
        <c:grouping val="standard"/>
        <c:varyColors val="0"/>
        <c:ser>
          <c:idx val="0"/>
          <c:order val="0"/>
          <c:tx>
            <c:v>0.06 mg/kg</c:v>
          </c:tx>
          <c:marker>
            <c:symbol val="none"/>
          </c:marker>
          <c:cat>
            <c:strLit>
              <c:ptCount val="9"/>
              <c:pt idx="0">
                <c:v>screening period</c:v>
              </c:pt>
              <c:pt idx="1">
                <c:v>D1</c:v>
              </c:pt>
              <c:pt idx="2">
                <c:v>D2</c:v>
              </c:pt>
              <c:pt idx="3">
                <c:v>D3</c:v>
              </c:pt>
              <c:pt idx="4">
                <c:v>D4</c:v>
              </c:pt>
              <c:pt idx="5">
                <c:v>D5</c:v>
              </c:pt>
              <c:pt idx="6">
                <c:v>D6</c:v>
              </c:pt>
              <c:pt idx="7">
                <c:v>D7</c:v>
              </c:pt>
              <c:pt idx="8">
                <c:v>D8</c:v>
              </c:pt>
            </c:strLit>
          </c:cat>
          <c:val>
            <c:numRef>
              <c:f>SOFA均值!$C$3:$K$3</c:f>
              <c:numCache>
                <c:formatCode>General</c:formatCode>
                <c:ptCount val="9"/>
                <c:pt idx="0">
                  <c:v>9.25</c:v>
                </c:pt>
                <c:pt idx="1">
                  <c:v>6.75</c:v>
                </c:pt>
                <c:pt idx="2">
                  <c:v>5.75</c:v>
                </c:pt>
                <c:pt idx="3">
                  <c:v>6.5</c:v>
                </c:pt>
                <c:pt idx="4">
                  <c:v>5.75</c:v>
                </c:pt>
                <c:pt idx="5">
                  <c:v>5</c:v>
                </c:pt>
                <c:pt idx="6">
                  <c:v>4.5</c:v>
                </c:pt>
                <c:pt idx="7">
                  <c:v>4.25</c:v>
                </c:pt>
                <c:pt idx="8">
                  <c:v>4</c:v>
                </c:pt>
              </c:numCache>
            </c:numRef>
          </c:val>
          <c:smooth val="0"/>
        </c:ser>
        <c:ser>
          <c:idx val="1"/>
          <c:order val="1"/>
          <c:tx>
            <c:v>0.12 mg/kg</c:v>
          </c:tx>
          <c:marker>
            <c:symbol val="none"/>
          </c:marker>
          <c:cat>
            <c:strLit>
              <c:ptCount val="9"/>
              <c:pt idx="0">
                <c:v>screening period</c:v>
              </c:pt>
              <c:pt idx="1">
                <c:v>D1</c:v>
              </c:pt>
              <c:pt idx="2">
                <c:v>D2</c:v>
              </c:pt>
              <c:pt idx="3">
                <c:v>D3</c:v>
              </c:pt>
              <c:pt idx="4">
                <c:v>D4</c:v>
              </c:pt>
              <c:pt idx="5">
                <c:v>D5</c:v>
              </c:pt>
              <c:pt idx="6">
                <c:v>D6</c:v>
              </c:pt>
              <c:pt idx="7">
                <c:v>D7</c:v>
              </c:pt>
              <c:pt idx="8">
                <c:v>D8</c:v>
              </c:pt>
            </c:strLit>
          </c:cat>
          <c:val>
            <c:numRef>
              <c:f>SOFA均值!$C$4:$K$4</c:f>
              <c:numCache>
                <c:formatCode>0.00_ </c:formatCode>
                <c:ptCount val="9"/>
                <c:pt idx="0">
                  <c:v>9.5555555555555554</c:v>
                </c:pt>
                <c:pt idx="1">
                  <c:v>8.8888888888888893</c:v>
                </c:pt>
                <c:pt idx="2">
                  <c:v>8.8888888888888893</c:v>
                </c:pt>
                <c:pt idx="3">
                  <c:v>8</c:v>
                </c:pt>
                <c:pt idx="4">
                  <c:v>7.5714285714285712</c:v>
                </c:pt>
                <c:pt idx="5">
                  <c:v>5.8571428571428568</c:v>
                </c:pt>
                <c:pt idx="6">
                  <c:v>5.1428571428571432</c:v>
                </c:pt>
                <c:pt idx="7">
                  <c:v>4.4285714285714288</c:v>
                </c:pt>
                <c:pt idx="8">
                  <c:v>4.5714285714285712</c:v>
                </c:pt>
              </c:numCache>
            </c:numRef>
          </c:val>
          <c:smooth val="0"/>
        </c:ser>
        <c:ser>
          <c:idx val="2"/>
          <c:order val="2"/>
          <c:tx>
            <c:v>0.24 mg/kg</c:v>
          </c:tx>
          <c:marker>
            <c:symbol val="none"/>
          </c:marker>
          <c:cat>
            <c:strLit>
              <c:ptCount val="9"/>
              <c:pt idx="0">
                <c:v>screening period</c:v>
              </c:pt>
              <c:pt idx="1">
                <c:v>D1</c:v>
              </c:pt>
              <c:pt idx="2">
                <c:v>D2</c:v>
              </c:pt>
              <c:pt idx="3">
                <c:v>D3</c:v>
              </c:pt>
              <c:pt idx="4">
                <c:v>D4</c:v>
              </c:pt>
              <c:pt idx="5">
                <c:v>D5</c:v>
              </c:pt>
              <c:pt idx="6">
                <c:v>D6</c:v>
              </c:pt>
              <c:pt idx="7">
                <c:v>D7</c:v>
              </c:pt>
              <c:pt idx="8">
                <c:v>D8</c:v>
              </c:pt>
            </c:strLit>
          </c:cat>
          <c:val>
            <c:numRef>
              <c:f>SOFA均值!$C$5:$K$5</c:f>
              <c:numCache>
                <c:formatCode>0.00_ </c:formatCode>
                <c:ptCount val="9"/>
                <c:pt idx="0">
                  <c:v>10.090909090909092</c:v>
                </c:pt>
                <c:pt idx="1">
                  <c:v>8.6363636363636367</c:v>
                </c:pt>
                <c:pt idx="2">
                  <c:v>7.8181818181818183</c:v>
                </c:pt>
                <c:pt idx="3">
                  <c:v>7.0909090909090908</c:v>
                </c:pt>
                <c:pt idx="4">
                  <c:v>6.0909090909090908</c:v>
                </c:pt>
                <c:pt idx="5">
                  <c:v>5.8</c:v>
                </c:pt>
                <c:pt idx="6">
                  <c:v>6.1</c:v>
                </c:pt>
                <c:pt idx="7">
                  <c:v>6</c:v>
                </c:pt>
                <c:pt idx="8">
                  <c:v>3.125</c:v>
                </c:pt>
              </c:numCache>
            </c:numRef>
          </c:val>
          <c:smooth val="0"/>
        </c:ser>
        <c:ser>
          <c:idx val="3"/>
          <c:order val="3"/>
          <c:tx>
            <c:v>placebo</c:v>
          </c:tx>
          <c:marker>
            <c:symbol val="none"/>
          </c:marker>
          <c:cat>
            <c:strLit>
              <c:ptCount val="9"/>
              <c:pt idx="0">
                <c:v>screening period</c:v>
              </c:pt>
              <c:pt idx="1">
                <c:v>D1</c:v>
              </c:pt>
              <c:pt idx="2">
                <c:v>D2</c:v>
              </c:pt>
              <c:pt idx="3">
                <c:v>D3</c:v>
              </c:pt>
              <c:pt idx="4">
                <c:v>D4</c:v>
              </c:pt>
              <c:pt idx="5">
                <c:v>D5</c:v>
              </c:pt>
              <c:pt idx="6">
                <c:v>D6</c:v>
              </c:pt>
              <c:pt idx="7">
                <c:v>D7</c:v>
              </c:pt>
              <c:pt idx="8">
                <c:v>D8</c:v>
              </c:pt>
            </c:strLit>
          </c:cat>
          <c:val>
            <c:numRef>
              <c:f>SOFA均值!$C$6:$K$6</c:f>
              <c:numCache>
                <c:formatCode>0.00_ </c:formatCode>
                <c:ptCount val="9"/>
                <c:pt idx="0">
                  <c:v>12.1</c:v>
                </c:pt>
                <c:pt idx="1">
                  <c:v>11.1</c:v>
                </c:pt>
                <c:pt idx="2">
                  <c:v>11.1</c:v>
                </c:pt>
                <c:pt idx="3">
                  <c:v>10.5</c:v>
                </c:pt>
                <c:pt idx="4">
                  <c:v>8.8000000000000007</c:v>
                </c:pt>
                <c:pt idx="5">
                  <c:v>8.6666666666666661</c:v>
                </c:pt>
                <c:pt idx="6">
                  <c:v>8.875</c:v>
                </c:pt>
                <c:pt idx="7">
                  <c:v>9.4285714285714288</c:v>
                </c:pt>
                <c:pt idx="8">
                  <c:v>9.1428571428571423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187950976"/>
        <c:axId val="1187948256"/>
      </c:lineChart>
      <c:catAx>
        <c:axId val="118795097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ime (day)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</c:title>
        <c:numFmt formatCode="General" sourceLinked="0"/>
        <c:majorTickMark val="none"/>
        <c:minorTickMark val="none"/>
        <c:tickLblPos val="nextTo"/>
        <c:crossAx val="1187948256"/>
        <c:crosses val="autoZero"/>
        <c:auto val="1"/>
        <c:lblAlgn val="ctr"/>
        <c:lblOffset val="100"/>
        <c:noMultiLvlLbl val="0"/>
      </c:catAx>
      <c:valAx>
        <c:axId val="1187948256"/>
        <c:scaling>
          <c:orientation val="minMax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/>
                </a:pPr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OFA</a:t>
                </a:r>
                <a:r>
                  <a:rPr lang="en-US" altLang="zh-CN" sz="1400" baseline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score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crossAx val="1187950976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2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0A691C2-3C47-4ED1-A8FE-44DDDC9F8545}" type="datetimeFigureOut">
              <a:rPr lang="zh-CN" altLang="en-US" smtClean="0"/>
              <a:t>2021/2/1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96A8EA5-EC67-4CE2-BC9A-B6F1AE6FD9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91129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96A8EA5-EC67-4CE2-BC9A-B6F1AE6FD96F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1648547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CB340F-7A8B-43FE-B4FB-38E3465321DC}" type="datetimeFigureOut">
              <a:rPr lang="zh-CN" altLang="en-US" smtClean="0"/>
              <a:t>2021/2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BA2906-7BAE-4F56-AD42-66038E9333B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04394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CB340F-7A8B-43FE-B4FB-38E3465321DC}" type="datetimeFigureOut">
              <a:rPr lang="zh-CN" altLang="en-US" smtClean="0"/>
              <a:t>2021/2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BA2906-7BAE-4F56-AD42-66038E9333B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80331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CB340F-7A8B-43FE-B4FB-38E3465321DC}" type="datetimeFigureOut">
              <a:rPr lang="zh-CN" altLang="en-US" smtClean="0"/>
              <a:t>2021/2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BA2906-7BAE-4F56-AD42-66038E9333B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545486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CB340F-7A8B-43FE-B4FB-38E3465321DC}" type="datetimeFigureOut">
              <a:rPr lang="zh-CN" altLang="en-US" smtClean="0"/>
              <a:t>2021/2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BA2906-7BAE-4F56-AD42-66038E9333B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199080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CB340F-7A8B-43FE-B4FB-38E3465321DC}" type="datetimeFigureOut">
              <a:rPr lang="zh-CN" altLang="en-US" smtClean="0"/>
              <a:t>2021/2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BA2906-7BAE-4F56-AD42-66038E9333B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339903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CB340F-7A8B-43FE-B4FB-38E3465321DC}" type="datetimeFigureOut">
              <a:rPr lang="zh-CN" altLang="en-US" smtClean="0"/>
              <a:t>2021/2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BA2906-7BAE-4F56-AD42-66038E9333B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66328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CB340F-7A8B-43FE-B4FB-38E3465321DC}" type="datetimeFigureOut">
              <a:rPr lang="zh-CN" altLang="en-US" smtClean="0"/>
              <a:t>2021/2/1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BA2906-7BAE-4F56-AD42-66038E9333B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977404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CB340F-7A8B-43FE-B4FB-38E3465321DC}" type="datetimeFigureOut">
              <a:rPr lang="zh-CN" altLang="en-US" smtClean="0"/>
              <a:t>2021/2/1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BA2906-7BAE-4F56-AD42-66038E9333B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863206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CB340F-7A8B-43FE-B4FB-38E3465321DC}" type="datetimeFigureOut">
              <a:rPr lang="zh-CN" altLang="en-US" smtClean="0"/>
              <a:t>2021/2/1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BA2906-7BAE-4F56-AD42-66038E9333B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067099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CB340F-7A8B-43FE-B4FB-38E3465321DC}" type="datetimeFigureOut">
              <a:rPr lang="zh-CN" altLang="en-US" smtClean="0"/>
              <a:t>2021/2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BA2906-7BAE-4F56-AD42-66038E9333B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04666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CB340F-7A8B-43FE-B4FB-38E3465321DC}" type="datetimeFigureOut">
              <a:rPr lang="zh-CN" altLang="en-US" smtClean="0"/>
              <a:t>2021/2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BA2906-7BAE-4F56-AD42-66038E9333B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06775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CB340F-7A8B-43FE-B4FB-38E3465321DC}" type="datetimeFigureOut">
              <a:rPr lang="zh-CN" altLang="en-US" smtClean="0"/>
              <a:t>2021/2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BA2906-7BAE-4F56-AD42-66038E9333B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660381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67311" y="1317171"/>
            <a:ext cx="4708973" cy="3331029"/>
          </a:xfrm>
          <a:prstGeom prst="rect">
            <a:avLst/>
          </a:prstGeom>
        </p:spPr>
      </p:pic>
      <p:sp>
        <p:nvSpPr>
          <p:cNvPr id="7" name="矩形 6"/>
          <p:cNvSpPr/>
          <p:nvPr/>
        </p:nvSpPr>
        <p:spPr>
          <a:xfrm>
            <a:off x="2884714" y="5087036"/>
            <a:ext cx="6096000" cy="307777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Concentrations versus time profiles per group. (a)Day1 (b) Day 7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28690" y="1112737"/>
            <a:ext cx="5154396" cy="35354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503241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2754084" y="5478921"/>
            <a:ext cx="768531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indent="1085850" algn="just">
              <a:spcAft>
                <a:spcPts val="0"/>
              </a:spcAft>
            </a:pPr>
            <a:r>
              <a:rPr lang="en-US" altLang="zh-CN" sz="1400" b="1" kern="100" dirty="0">
                <a:solidFill>
                  <a:srgbClr val="3E3D4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lang="en-US" altLang="zh-CN" sz="1400" kern="100" dirty="0">
                <a:solidFill>
                  <a:srgbClr val="3E3D4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SOFA </a:t>
            </a:r>
            <a:r>
              <a:rPr lang="en-US" altLang="zh-CN" sz="1400" kern="100" dirty="0" smtClean="0">
                <a:solidFill>
                  <a:srgbClr val="3E3D4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core versus </a:t>
            </a:r>
            <a:r>
              <a:rPr lang="en-US" altLang="zh-CN" sz="1400" kern="100" dirty="0">
                <a:solidFill>
                  <a:srgbClr val="3E3D4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ime profiles per group</a:t>
            </a:r>
            <a:endParaRPr lang="zh-CN" altLang="zh-CN" sz="140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图表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4086356"/>
              </p:ext>
            </p:extLst>
          </p:nvPr>
        </p:nvGraphicFramePr>
        <p:xfrm>
          <a:off x="2671762" y="1581150"/>
          <a:ext cx="6848475" cy="36957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23192048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598</TotalTime>
  <Words>34</Words>
  <Application>Microsoft Office PowerPoint</Application>
  <PresentationFormat>宽屏</PresentationFormat>
  <Paragraphs>5</Paragraphs>
  <Slides>2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8" baseType="lpstr"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HH</dc:creator>
  <cp:lastModifiedBy>WHH</cp:lastModifiedBy>
  <cp:revision>40</cp:revision>
  <dcterms:created xsi:type="dcterms:W3CDTF">2020-12-01T08:48:30Z</dcterms:created>
  <dcterms:modified xsi:type="dcterms:W3CDTF">2021-02-10T04:31:30Z</dcterms:modified>
</cp:coreProperties>
</file>